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7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69E2F-43AE-48EF-B480-40B03528CB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AE9632-4896-488C-B369-98F218D714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7D615-3163-4FB4-8166-BE9CDF100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903B71-71E8-4F3E-8D95-29F5C0A68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55D5A6-EF57-4912-8730-3AC09D0E4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1165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22993E-35CD-4CF7-93CA-C1F81673F7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A0B005-B24F-454E-8406-49196D5C19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7129B-DE0D-4B94-98A8-576ADCA04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FBBDB-9CBF-4AFA-849C-7A77A5610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0721BD-3485-421D-8E99-F7045C5F8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37210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D26F5F-4270-4D12-BABD-7417B7B394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FA7F75-F3AD-4E0C-B182-BA037B578E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F5ACA4-BB21-4B27-B6F7-D03B85C32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529109-300E-4188-9FF4-83D705253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737675-A7B0-40A4-9858-687F7F624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1415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D60D48-6DF3-47E1-A392-95690F7DD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6D9E88-F46D-4655-AE59-E0020BC471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42F7E0-6F1F-4866-A9F1-C3E3AE3DE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F238C9-F44A-45D2-8604-A8680830B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0275C3-0672-4418-B99B-C69B97F53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5603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65C83-2EC3-407C-98FC-A68BFE95E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C3733D-4C03-4FD6-A87D-2282B27400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908B2-1DD8-413E-890A-E2939D3CB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6C4602-B9B9-440C-892D-EBB774661C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9166C-860F-4D0D-89FD-48E40A9E9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9910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FDD73B-A7ED-4917-B541-A576440EC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130D5D-02F6-4702-8D03-9074BC112A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F2DFDC-F03A-429C-B115-FF6522F7FC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96A113-D4AC-4D36-A39C-839D80E06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45CEBA-F7F1-40BE-9F5D-A431E66D3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C772D5-714B-4FA9-B0C1-5E805F039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4094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50A1CF-84CC-49DC-BD66-7BC20DB47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276DC5-E2DA-472C-A31B-0B4FBD241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771C49-1291-44D7-A03F-96F490C208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DFEF6A-3858-4BE8-8FC2-81EB14F9E1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2927BB-0C9F-459E-8D5A-6FEC6AF0F9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266B6B-45D7-4D3A-8EEC-F43EFAFA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BA580F-D60E-40BC-868F-CD03FD2CF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14A943-E22B-41EF-A427-E1FA92BA3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03877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EB965-B9A6-42D4-9289-A035D0179A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E2BE668-47ED-4B3A-83D3-D35EB2B30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B5F736-122B-41F3-8B6B-9787E0637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1FCEA9-D878-44C1-A245-D5FA27F6E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38549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EC0914-B482-418F-9E99-282586B62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7B0AA8-89BC-491A-8C37-131DC6833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4DD44C-68E6-4473-A0A5-8334B9E82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9594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344B7-A828-48AB-9003-D5E31F14E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F48A7A-3202-4F15-A1DB-43889F2042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DB0387-8761-4433-8614-DC19F15BC0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32E230-9E4E-4094-B165-84AF885F6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2C80D4-82AD-4F5C-93E8-8BC24F8A6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E3321B-0FEE-453D-898F-3BDE168AE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3398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E1A02C-170D-406A-BC00-48EE21DCE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20E9E5-6433-4DA1-941A-5BE1D488C9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F569AE-3F69-42CB-8DF0-05F373FD8D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86CC70-775E-4B8C-A032-B2C17C273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69C6E0-7492-4F34-BCA2-CD85DC99B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8650A9-F3FA-4798-9810-2D5B3B302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7278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541AEF-133B-4721-A8AC-CCA259236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77A512-2DE1-4750-B01B-029BDA2709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8FD228-8E71-415E-875A-B3BAF7C39A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3E562-88F6-4167-BE39-637AD3A46D37}" type="datetimeFigureOut">
              <a:rPr lang="en-IN" smtClean="0"/>
              <a:t>01-12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2F6DD-51AD-4258-8645-4D24523C43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4AB37-A760-401B-9975-266B98E0E3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95854-709A-4CD0-B7EE-2FBC6578C43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4946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C469EC01-240D-4C16-97DD-519BDC9411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6" t="22075" r="22515" b="24074"/>
          <a:stretch/>
        </p:blipFill>
        <p:spPr>
          <a:xfrm>
            <a:off x="2072433" y="3867510"/>
            <a:ext cx="8567280" cy="29904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14116CC-6FD5-4A8A-809B-062407A5C82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02" t="7975" r="30564" b="28169"/>
          <a:stretch/>
        </p:blipFill>
        <p:spPr>
          <a:xfrm>
            <a:off x="2265871" y="535474"/>
            <a:ext cx="7660257" cy="37111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57CE2E-A1F2-424B-90F3-65C987D1B965}"/>
              </a:ext>
            </a:extLst>
          </p:cNvPr>
          <p:cNvSpPr txBox="1"/>
          <p:nvPr/>
        </p:nvSpPr>
        <p:spPr>
          <a:xfrm>
            <a:off x="4005492" y="0"/>
            <a:ext cx="4181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9 A representative uncropped image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970BDA7-BDF4-4FAF-8E22-2C1EF14D0A12}"/>
              </a:ext>
            </a:extLst>
          </p:cNvPr>
          <p:cNvGrpSpPr/>
          <p:nvPr/>
        </p:nvGrpSpPr>
        <p:grpSpPr>
          <a:xfrm>
            <a:off x="3807463" y="744760"/>
            <a:ext cx="5141343" cy="307786"/>
            <a:chOff x="3807463" y="744760"/>
            <a:chExt cx="5141343" cy="30778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6271A0D-8FF9-43DA-B773-E4F8B67EDC10}"/>
                </a:ext>
              </a:extLst>
            </p:cNvPr>
            <p:cNvSpPr txBox="1"/>
            <p:nvPr/>
          </p:nvSpPr>
          <p:spPr>
            <a:xfrm>
              <a:off x="8031035" y="744769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4F1B596-302B-466E-9B5E-594D5FDD8E12}"/>
                </a:ext>
              </a:extLst>
            </p:cNvPr>
            <p:cNvSpPr txBox="1"/>
            <p:nvPr/>
          </p:nvSpPr>
          <p:spPr>
            <a:xfrm>
              <a:off x="7067752" y="744768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605044F-0A1A-4877-BC64-B699D2C48E86}"/>
                </a:ext>
              </a:extLst>
            </p:cNvPr>
            <p:cNvSpPr txBox="1"/>
            <p:nvPr/>
          </p:nvSpPr>
          <p:spPr>
            <a:xfrm>
              <a:off x="6104469" y="744767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83206A5-CC22-404C-B3CE-DD014B7CCE1B}"/>
                </a:ext>
              </a:extLst>
            </p:cNvPr>
            <p:cNvSpPr txBox="1"/>
            <p:nvPr/>
          </p:nvSpPr>
          <p:spPr>
            <a:xfrm>
              <a:off x="5172659" y="744766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186C4E6-7F22-4FD7-BEA3-F36C9C5906C4}"/>
                </a:ext>
              </a:extLst>
            </p:cNvPr>
            <p:cNvSpPr txBox="1"/>
            <p:nvPr/>
          </p:nvSpPr>
          <p:spPr>
            <a:xfrm>
              <a:off x="4240849" y="744765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607CADD-AB38-47AB-918E-DB990C661962}"/>
                </a:ext>
              </a:extLst>
            </p:cNvPr>
            <p:cNvSpPr txBox="1"/>
            <p:nvPr/>
          </p:nvSpPr>
          <p:spPr>
            <a:xfrm>
              <a:off x="3807463" y="744764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/>
                <a:t>Scr</a:t>
              </a:r>
              <a:endParaRPr 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98B0FE8-23B5-477A-BB98-A1AA83A1797D}"/>
                </a:ext>
              </a:extLst>
            </p:cNvPr>
            <p:cNvSpPr txBox="1"/>
            <p:nvPr/>
          </p:nvSpPr>
          <p:spPr>
            <a:xfrm>
              <a:off x="8445597" y="744763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CDE35AF-5BB0-473A-96AC-80BFAA5FFBA2}"/>
                </a:ext>
              </a:extLst>
            </p:cNvPr>
            <p:cNvSpPr txBox="1"/>
            <p:nvPr/>
          </p:nvSpPr>
          <p:spPr>
            <a:xfrm>
              <a:off x="7531667" y="744762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E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A6B1CC5-DE85-458B-8765-92626048F7B7}"/>
                </a:ext>
              </a:extLst>
            </p:cNvPr>
            <p:cNvSpPr txBox="1"/>
            <p:nvPr/>
          </p:nvSpPr>
          <p:spPr>
            <a:xfrm>
              <a:off x="6571493" y="744761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347612B-2EDC-44ED-B9BE-3F89F39FDF23}"/>
                </a:ext>
              </a:extLst>
            </p:cNvPr>
            <p:cNvSpPr txBox="1"/>
            <p:nvPr/>
          </p:nvSpPr>
          <p:spPr>
            <a:xfrm>
              <a:off x="5601511" y="744761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E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12F5B55-AF69-4639-BAF6-93AE1AFAAFB1}"/>
                </a:ext>
              </a:extLst>
            </p:cNvPr>
            <p:cNvSpPr txBox="1"/>
            <p:nvPr/>
          </p:nvSpPr>
          <p:spPr>
            <a:xfrm>
              <a:off x="4676400" y="744760"/>
              <a:ext cx="503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E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05DED28C-1A7F-4D5D-A002-D0A4A12E3DCB}"/>
              </a:ext>
            </a:extLst>
          </p:cNvPr>
          <p:cNvSpPr txBox="1"/>
          <p:nvPr/>
        </p:nvSpPr>
        <p:spPr>
          <a:xfrm>
            <a:off x="7588394" y="4103826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04AFF4-8171-4312-8AA7-5E6F778AF204}"/>
              </a:ext>
            </a:extLst>
          </p:cNvPr>
          <p:cNvSpPr txBox="1"/>
          <p:nvPr/>
        </p:nvSpPr>
        <p:spPr>
          <a:xfrm>
            <a:off x="6723531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960F325-E60F-44DC-98C7-3D5315EF436F}"/>
              </a:ext>
            </a:extLst>
          </p:cNvPr>
          <p:cNvSpPr txBox="1"/>
          <p:nvPr/>
        </p:nvSpPr>
        <p:spPr>
          <a:xfrm>
            <a:off x="5815733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45778F-92EE-4444-9298-015E2374EF71}"/>
              </a:ext>
            </a:extLst>
          </p:cNvPr>
          <p:cNvSpPr txBox="1"/>
          <p:nvPr/>
        </p:nvSpPr>
        <p:spPr>
          <a:xfrm>
            <a:off x="4924268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71AB34-244C-40A5-B461-7B65B538493B}"/>
              </a:ext>
            </a:extLst>
          </p:cNvPr>
          <p:cNvSpPr txBox="1"/>
          <p:nvPr/>
        </p:nvSpPr>
        <p:spPr>
          <a:xfrm>
            <a:off x="4031684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A8D85B3-F090-4151-A661-C8066E9724E0}"/>
              </a:ext>
            </a:extLst>
          </p:cNvPr>
          <p:cNvSpPr txBox="1"/>
          <p:nvPr/>
        </p:nvSpPr>
        <p:spPr>
          <a:xfrm>
            <a:off x="3622133" y="4103826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D3C850-9A4C-43D5-B768-187340472384}"/>
              </a:ext>
            </a:extLst>
          </p:cNvPr>
          <p:cNvSpPr txBox="1"/>
          <p:nvPr/>
        </p:nvSpPr>
        <p:spPr>
          <a:xfrm>
            <a:off x="8016995" y="4103826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38B12A-6124-4E7D-9F24-31D1A7ED9840}"/>
              </a:ext>
            </a:extLst>
          </p:cNvPr>
          <p:cNvSpPr txBox="1"/>
          <p:nvPr/>
        </p:nvSpPr>
        <p:spPr>
          <a:xfrm>
            <a:off x="7152132" y="4107229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FFE46F-123E-4449-BB3F-0DCF93AE18CE}"/>
              </a:ext>
            </a:extLst>
          </p:cNvPr>
          <p:cNvSpPr txBox="1"/>
          <p:nvPr/>
        </p:nvSpPr>
        <p:spPr>
          <a:xfrm>
            <a:off x="6250998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4915585-5ED4-4E18-BCFA-D29A85DF7528}"/>
              </a:ext>
            </a:extLst>
          </p:cNvPr>
          <p:cNvSpPr txBox="1"/>
          <p:nvPr/>
        </p:nvSpPr>
        <p:spPr>
          <a:xfrm>
            <a:off x="5369201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9742540-D3BB-4262-BD86-5823E4CAF8A9}"/>
              </a:ext>
            </a:extLst>
          </p:cNvPr>
          <p:cNvSpPr txBox="1"/>
          <p:nvPr/>
        </p:nvSpPr>
        <p:spPr>
          <a:xfrm>
            <a:off x="4495667" y="4110632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147491-B2D3-4E80-8E75-CF59208C77E1}"/>
              </a:ext>
            </a:extLst>
          </p:cNvPr>
          <p:cNvSpPr txBox="1"/>
          <p:nvPr/>
        </p:nvSpPr>
        <p:spPr>
          <a:xfrm>
            <a:off x="5748959" y="41616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798E803-2C40-4717-9919-5B771A43A377}"/>
              </a:ext>
            </a:extLst>
          </p:cNvPr>
          <p:cNvSpPr txBox="1"/>
          <p:nvPr/>
        </p:nvSpPr>
        <p:spPr>
          <a:xfrm>
            <a:off x="5567647" y="3734494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2195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E4778060-F1E4-48F9-97A9-AA46B6390F3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983" t="10923" r="20013" b="46990"/>
          <a:stretch/>
        </p:blipFill>
        <p:spPr>
          <a:xfrm flipH="1">
            <a:off x="3861880" y="4425215"/>
            <a:ext cx="4620453" cy="243278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CA8A052-206A-4586-B0F4-ED87B86B250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570" t="7513" r="15885" b="31464"/>
          <a:stretch/>
        </p:blipFill>
        <p:spPr>
          <a:xfrm flipH="1">
            <a:off x="3746404" y="546283"/>
            <a:ext cx="4638133" cy="331832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57CE2E-A1F2-424B-90F3-65C987D1B965}"/>
              </a:ext>
            </a:extLst>
          </p:cNvPr>
          <p:cNvSpPr txBox="1"/>
          <p:nvPr/>
        </p:nvSpPr>
        <p:spPr>
          <a:xfrm>
            <a:off x="4005492" y="0"/>
            <a:ext cx="4181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9 B representative uncropped imag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271A0D-8FF9-43DA-B773-E4F8B67EDC10}"/>
              </a:ext>
            </a:extLst>
          </p:cNvPr>
          <p:cNvSpPr txBox="1"/>
          <p:nvPr/>
        </p:nvSpPr>
        <p:spPr>
          <a:xfrm>
            <a:off x="6754207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4F1B596-302B-466E-9B5E-594D5FDD8E12}"/>
              </a:ext>
            </a:extLst>
          </p:cNvPr>
          <p:cNvSpPr txBox="1"/>
          <p:nvPr/>
        </p:nvSpPr>
        <p:spPr>
          <a:xfrm>
            <a:off x="6172107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05044F-0A1A-4877-BC64-B699D2C48E86}"/>
              </a:ext>
            </a:extLst>
          </p:cNvPr>
          <p:cNvSpPr txBox="1"/>
          <p:nvPr/>
        </p:nvSpPr>
        <p:spPr>
          <a:xfrm>
            <a:off x="5637636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83206A5-CC22-404C-B3CE-DD014B7CCE1B}"/>
              </a:ext>
            </a:extLst>
          </p:cNvPr>
          <p:cNvSpPr txBox="1"/>
          <p:nvPr/>
        </p:nvSpPr>
        <p:spPr>
          <a:xfrm>
            <a:off x="5135445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86C4E6-7F22-4FD7-BEA3-F36C9C5906C4}"/>
              </a:ext>
            </a:extLst>
          </p:cNvPr>
          <p:cNvSpPr txBox="1"/>
          <p:nvPr/>
        </p:nvSpPr>
        <p:spPr>
          <a:xfrm>
            <a:off x="4571393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8B0FE8-23B5-477A-BB98-A1AA83A1797D}"/>
              </a:ext>
            </a:extLst>
          </p:cNvPr>
          <p:cNvSpPr txBox="1"/>
          <p:nvPr/>
        </p:nvSpPr>
        <p:spPr>
          <a:xfrm>
            <a:off x="7117400" y="750625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CDE35AF-5BB0-473A-96AC-80BFAA5FFBA2}"/>
              </a:ext>
            </a:extLst>
          </p:cNvPr>
          <p:cNvSpPr txBox="1"/>
          <p:nvPr/>
        </p:nvSpPr>
        <p:spPr>
          <a:xfrm>
            <a:off x="6439100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6B1CC5-DE85-458B-8765-92626048F7B7}"/>
              </a:ext>
            </a:extLst>
          </p:cNvPr>
          <p:cNvSpPr txBox="1"/>
          <p:nvPr/>
        </p:nvSpPr>
        <p:spPr>
          <a:xfrm>
            <a:off x="5886417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47612B-2EDC-44ED-B9BE-3F89F39FDF23}"/>
              </a:ext>
            </a:extLst>
          </p:cNvPr>
          <p:cNvSpPr txBox="1"/>
          <p:nvPr/>
        </p:nvSpPr>
        <p:spPr>
          <a:xfrm>
            <a:off x="5396382" y="745929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12F5B55-AF69-4639-BAF6-93AE1AFAAFB1}"/>
              </a:ext>
            </a:extLst>
          </p:cNvPr>
          <p:cNvSpPr txBox="1"/>
          <p:nvPr/>
        </p:nvSpPr>
        <p:spPr>
          <a:xfrm>
            <a:off x="4846823" y="7447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DED28C-1A7F-4D5D-A002-D0A4A12E3DCB}"/>
              </a:ext>
            </a:extLst>
          </p:cNvPr>
          <p:cNvSpPr txBox="1"/>
          <p:nvPr/>
        </p:nvSpPr>
        <p:spPr>
          <a:xfrm>
            <a:off x="7455807" y="4614366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F04AFF4-8171-4312-8AA7-5E6F778AF204}"/>
              </a:ext>
            </a:extLst>
          </p:cNvPr>
          <p:cNvSpPr txBox="1"/>
          <p:nvPr/>
        </p:nvSpPr>
        <p:spPr>
          <a:xfrm>
            <a:off x="6773747" y="4607560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960F325-E60F-44DC-98C7-3D5315EF436F}"/>
              </a:ext>
            </a:extLst>
          </p:cNvPr>
          <p:cNvSpPr txBox="1"/>
          <p:nvPr/>
        </p:nvSpPr>
        <p:spPr>
          <a:xfrm>
            <a:off x="6165478" y="4614367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45778F-92EE-4444-9298-015E2374EF71}"/>
              </a:ext>
            </a:extLst>
          </p:cNvPr>
          <p:cNvSpPr txBox="1"/>
          <p:nvPr/>
        </p:nvSpPr>
        <p:spPr>
          <a:xfrm>
            <a:off x="5570855" y="461096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71AB34-244C-40A5-B461-7B65B538493B}"/>
              </a:ext>
            </a:extLst>
          </p:cNvPr>
          <p:cNvSpPr txBox="1"/>
          <p:nvPr/>
        </p:nvSpPr>
        <p:spPr>
          <a:xfrm>
            <a:off x="4875149" y="461096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Scr</a:t>
            </a:r>
            <a:endParaRPr 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BD3C850-9A4C-43D5-B768-187340472384}"/>
              </a:ext>
            </a:extLst>
          </p:cNvPr>
          <p:cNvSpPr txBox="1"/>
          <p:nvPr/>
        </p:nvSpPr>
        <p:spPr>
          <a:xfrm>
            <a:off x="7996437" y="4607559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38B12A-6124-4E7D-9F24-31D1A7ED9840}"/>
              </a:ext>
            </a:extLst>
          </p:cNvPr>
          <p:cNvSpPr txBox="1"/>
          <p:nvPr/>
        </p:nvSpPr>
        <p:spPr>
          <a:xfrm>
            <a:off x="7117400" y="4614366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FFE46F-123E-4449-BB3F-0DCF93AE18CE}"/>
              </a:ext>
            </a:extLst>
          </p:cNvPr>
          <p:cNvSpPr txBox="1"/>
          <p:nvPr/>
        </p:nvSpPr>
        <p:spPr>
          <a:xfrm>
            <a:off x="6449698" y="4607561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4915585-5ED4-4E18-BCFA-D29A85DF7528}"/>
              </a:ext>
            </a:extLst>
          </p:cNvPr>
          <p:cNvSpPr txBox="1"/>
          <p:nvPr/>
        </p:nvSpPr>
        <p:spPr>
          <a:xfrm>
            <a:off x="5883975" y="461096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9742540-D3BB-4262-BD86-5823E4CAF8A9}"/>
              </a:ext>
            </a:extLst>
          </p:cNvPr>
          <p:cNvSpPr txBox="1"/>
          <p:nvPr/>
        </p:nvSpPr>
        <p:spPr>
          <a:xfrm>
            <a:off x="5239095" y="4610964"/>
            <a:ext cx="503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147491-B2D3-4E80-8E75-CF59208C77E1}"/>
              </a:ext>
            </a:extLst>
          </p:cNvPr>
          <p:cNvSpPr txBox="1"/>
          <p:nvPr/>
        </p:nvSpPr>
        <p:spPr>
          <a:xfrm>
            <a:off x="5742304" y="252419"/>
            <a:ext cx="646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IDH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798E803-2C40-4717-9919-5B771A43A377}"/>
              </a:ext>
            </a:extLst>
          </p:cNvPr>
          <p:cNvSpPr txBox="1"/>
          <p:nvPr/>
        </p:nvSpPr>
        <p:spPr>
          <a:xfrm>
            <a:off x="5567647" y="3958987"/>
            <a:ext cx="105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/>
              <a:t>α-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4745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 Boppana</dc:creator>
  <cp:lastModifiedBy>Srinivas Boppana</cp:lastModifiedBy>
  <cp:revision>3</cp:revision>
  <dcterms:created xsi:type="dcterms:W3CDTF">2021-12-01T02:11:38Z</dcterms:created>
  <dcterms:modified xsi:type="dcterms:W3CDTF">2021-12-01T07:28:05Z</dcterms:modified>
</cp:coreProperties>
</file>